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ECE84-8614-444D-BCC1-387C2B6218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3239A-B158-4550-9639-D0A7898596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B769A-3B30-4875-B2D1-630F52D7AA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5576A-9B23-40B3-9A1D-A47E69A7DC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7D0DD-2C22-4854-B98B-B0D62CD274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22621-6A61-43F6-8FD4-FB26FAB562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37CB6F-5CD2-49A4-8378-290DB9752B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D7418-85EC-48A3-B585-3D5482B82C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DCDB4-34D4-406D-AED0-E14143FD94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E10EF-61FE-493F-B5BB-73DCEBE79D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D5812-B93D-491E-A6B6-25E5BA795A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DEC6C-47DD-476E-9272-D4F660C70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AD2F5F-4FB1-4FF8-806E-2B340E9C5C4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500720" y="3068640"/>
            <a:ext cx="2735280" cy="10699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4500720" y="4221000"/>
            <a:ext cx="2735280" cy="8668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4500720" y="5154480"/>
            <a:ext cx="2735280" cy="5796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175280" y="3213000"/>
            <a:ext cx="46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708360" y="378936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0" y="5619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236000" y="34290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236000" y="44370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u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236000" y="524196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idne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92360" y="29973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24360" y="5493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0" y="292428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916360" y="549360"/>
            <a:ext cx="32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672240" y="1220760"/>
            <a:ext cx="125280" cy="13222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110360" y="1096920"/>
            <a:ext cx="127080" cy="14461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548480" y="1065240"/>
            <a:ext cx="127080" cy="14778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986600" y="1157400"/>
            <a:ext cx="125640" cy="138564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797520" y="1353960"/>
            <a:ext cx="128880" cy="1189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797520" y="1353960"/>
            <a:ext cx="128880" cy="11890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7237440" y="1530360"/>
            <a:ext cx="125280" cy="1012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237440" y="1530360"/>
            <a:ext cx="125280" cy="1012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7675560" y="1395360"/>
            <a:ext cx="125280" cy="1147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7675560" y="1395360"/>
            <a:ext cx="125280" cy="1147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8112240" y="1293840"/>
            <a:ext cx="126720" cy="1249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8112240" y="1293840"/>
            <a:ext cx="126720" cy="12492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6732720" y="1157400"/>
            <a:ext cx="0" cy="63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708600" y="115740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7169040" y="1055160"/>
            <a:ext cx="0" cy="41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148520" y="105552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7607160" y="1035000"/>
            <a:ext cx="0" cy="30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7586640" y="103500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V="1">
            <a:off x="8047080" y="1106280"/>
            <a:ext cx="0" cy="50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8023320" y="1106640"/>
            <a:ext cx="522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732720" y="1220760"/>
            <a:ext cx="0" cy="73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708600" y="129384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169040" y="1096920"/>
            <a:ext cx="0" cy="39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148520" y="113652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607160" y="1065240"/>
            <a:ext cx="0" cy="41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586640" y="110664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047080" y="1157400"/>
            <a:ext cx="0" cy="410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023320" y="1198440"/>
            <a:ext cx="522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6858000" y="1344600"/>
            <a:ext cx="0" cy="9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835680" y="134460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7296120" y="1374840"/>
            <a:ext cx="0" cy="155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7273800" y="137484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7734240" y="1365120"/>
            <a:ext cx="0" cy="30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711920" y="136512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8172360" y="1262160"/>
            <a:ext cx="0" cy="316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8150400" y="126216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858000" y="1353960"/>
            <a:ext cx="0" cy="11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835680" y="136512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7296120" y="1530360"/>
            <a:ext cx="0" cy="165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7273800" y="169560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7734240" y="1395360"/>
            <a:ext cx="0" cy="20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7711920" y="1415880"/>
            <a:ext cx="525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8172360" y="1293840"/>
            <a:ext cx="0" cy="19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150400" y="131292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583320" y="909720"/>
            <a:ext cx="0" cy="1633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583320" y="254304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583320" y="229536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583320" y="203688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583320" y="178920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583320" y="154152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583320" y="128268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583320" y="1035000"/>
            <a:ext cx="30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583320" y="2543040"/>
            <a:ext cx="1752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6583320" y="2499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7021440" y="2499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7459560" y="2499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7897680" y="2499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8335800" y="2499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653160" y="620640"/>
            <a:ext cx="169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iver weight/Body weigh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449040" y="24591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390000" y="22114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391440" y="1952640"/>
            <a:ext cx="180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390000" y="17049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390000" y="1457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390000" y="1198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6390000" y="9525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745320" y="2665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7183440" y="2665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621560" y="2665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8058240" y="2665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8350920" y="2665440"/>
            <a:ext cx="62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W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rot="16200000">
            <a:off x="5728680" y="1809000"/>
            <a:ext cx="968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ight (mg/g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478400" y="3733920"/>
            <a:ext cx="0" cy="9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87240" y="1665360"/>
            <a:ext cx="125640" cy="9475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108080" y="1260360"/>
            <a:ext cx="119160" cy="13525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521000" y="1450800"/>
            <a:ext cx="126720" cy="1162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941480" y="1687680"/>
            <a:ext cx="120600" cy="9252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812880" y="1816200"/>
            <a:ext cx="120600" cy="79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812880" y="1816200"/>
            <a:ext cx="120600" cy="796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227240" y="1571760"/>
            <a:ext cx="118800" cy="104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227240" y="1571760"/>
            <a:ext cx="118800" cy="10411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647720" y="1481040"/>
            <a:ext cx="119160" cy="1131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647720" y="1481040"/>
            <a:ext cx="119160" cy="11318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062080" y="1571760"/>
            <a:ext cx="119160" cy="104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062080" y="1571760"/>
            <a:ext cx="119160" cy="10411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750960" y="1375920"/>
            <a:ext cx="0" cy="289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728640" y="137628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V="1">
            <a:off x="1163520" y="1133640"/>
            <a:ext cx="0" cy="1267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143000" y="113364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1585800" y="1344240"/>
            <a:ext cx="0" cy="1062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563840" y="134460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1998720" y="1571760"/>
            <a:ext cx="0" cy="115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978200" y="157176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750960" y="1665360"/>
            <a:ext cx="0" cy="293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28640" y="195912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163520" y="1260360"/>
            <a:ext cx="0" cy="122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143000" y="138276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585800" y="1450800"/>
            <a:ext cx="0" cy="986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563840" y="15494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998720" y="1687680"/>
            <a:ext cx="0" cy="1126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978200" y="180036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870120" y="1770120"/>
            <a:ext cx="0" cy="46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849240" y="177012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1282680" y="1428480"/>
            <a:ext cx="0" cy="142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262160" y="14288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1703520" y="1436400"/>
            <a:ext cx="0" cy="44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682640" y="143676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2119320" y="1458720"/>
            <a:ext cx="0" cy="1126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097000" y="145908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870120" y="1816200"/>
            <a:ext cx="0" cy="44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849240" y="186048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282680" y="1571760"/>
            <a:ext cx="0" cy="1378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262160" y="17096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703520" y="1481040"/>
            <a:ext cx="0" cy="39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682640" y="152100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119320" y="1571760"/>
            <a:ext cx="0" cy="115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097000" y="168768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603360" y="966960"/>
            <a:ext cx="0" cy="1645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603360" y="261288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603360" y="224784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603360" y="188280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03360" y="151272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603360" y="114768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603360" y="2612880"/>
            <a:ext cx="1670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603360" y="2574720"/>
            <a:ext cx="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1023840" y="2574720"/>
            <a:ext cx="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1436760" y="2574720"/>
            <a:ext cx="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1857240" y="2574720"/>
            <a:ext cx="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2273400" y="2574720"/>
            <a:ext cx="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12000" y="620640"/>
            <a:ext cx="173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ody weight gain/Origin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48560" y="2544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84480" y="2179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84480" y="1816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384480" y="1444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84480" y="10796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749520" y="2719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162080" y="2719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584360" y="2719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997280" y="2719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216880" y="2741760"/>
            <a:ext cx="62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W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rot="16200000">
            <a:off x="-54360" y="1618200"/>
            <a:ext cx="65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ight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868320" y="4287960"/>
            <a:ext cx="119160" cy="7398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279440" y="4029120"/>
            <a:ext cx="117720" cy="99864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1689120" y="3876840"/>
            <a:ext cx="117360" cy="11509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092320" y="3594240"/>
            <a:ext cx="117360" cy="14335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987480" y="4657680"/>
            <a:ext cx="11736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987480" y="4657680"/>
            <a:ext cx="117360" cy="3700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1397160" y="4448160"/>
            <a:ext cx="117360" cy="57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397160" y="4448160"/>
            <a:ext cx="117360" cy="579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1806480" y="4513320"/>
            <a:ext cx="111240" cy="51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1806480" y="4513320"/>
            <a:ext cx="111240" cy="5144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209680" y="4070520"/>
            <a:ext cx="117720" cy="957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209680" y="4070520"/>
            <a:ext cx="117720" cy="9572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925560" y="4118040"/>
            <a:ext cx="0" cy="169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905040" y="411804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1335240" y="3852720"/>
            <a:ext cx="0" cy="176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314360" y="385272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1744560" y="3771720"/>
            <a:ext cx="0" cy="104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722600" y="377208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2147760" y="3336480"/>
            <a:ext cx="0" cy="257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127240" y="333684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925560" y="4287960"/>
            <a:ext cx="0" cy="1681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905040" y="445608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335240" y="4029120"/>
            <a:ext cx="0" cy="1760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1314360" y="420516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1744560" y="3876840"/>
            <a:ext cx="0" cy="102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722600" y="397980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147760" y="3594240"/>
            <a:ext cx="0" cy="264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127240" y="385920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flipV="1">
            <a:off x="1042920" y="4610160"/>
            <a:ext cx="0" cy="47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022400" y="461016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V="1">
            <a:off x="1452600" y="4317840"/>
            <a:ext cx="0" cy="1303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432080" y="43178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 flipV="1">
            <a:off x="1863720" y="4479480"/>
            <a:ext cx="0" cy="334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1841400" y="4479840"/>
            <a:ext cx="4788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V="1">
            <a:off x="2265480" y="3916440"/>
            <a:ext cx="0" cy="154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244600" y="391644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1042920" y="4657680"/>
            <a:ext cx="0" cy="55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1022400" y="471312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452600" y="4448160"/>
            <a:ext cx="0" cy="120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432080" y="456876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863720" y="4513320"/>
            <a:ext cx="0" cy="23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1841400" y="4537080"/>
            <a:ext cx="4788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265480" y="4070520"/>
            <a:ext cx="0" cy="1504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244600" y="422100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785880" y="3255840"/>
            <a:ext cx="0" cy="1771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785880" y="502776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785880" y="458640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785880" y="414180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785880" y="369900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785880" y="325584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785880" y="5027760"/>
            <a:ext cx="1631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flipV="1">
            <a:off x="785880" y="4987440"/>
            <a:ext cx="0" cy="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V="1">
            <a:off x="1195560" y="4987440"/>
            <a:ext cx="0" cy="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flipV="1">
            <a:off x="1604880" y="4987440"/>
            <a:ext cx="0" cy="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flipV="1">
            <a:off x="2009880" y="4987440"/>
            <a:ext cx="0" cy="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2417760" y="4987440"/>
            <a:ext cx="0" cy="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038960" y="2997360"/>
            <a:ext cx="995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leen Weigh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632520" y="4954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41440" y="45133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41440" y="4070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541440" y="3625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41440" y="31827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924120" y="5140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333800" y="5140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1743120" y="5140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152800" y="5140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2399400" y="5118120"/>
            <a:ext cx="62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W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rot="16200000">
            <a:off x="104040" y="3996360"/>
            <a:ext cx="70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Weight(g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376360" y="1301760"/>
            <a:ext cx="63720" cy="73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377080" y="1446120"/>
            <a:ext cx="23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340000" y="1773360"/>
            <a:ext cx="6336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678120" y="1398600"/>
            <a:ext cx="125640" cy="11365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4095720" y="1635120"/>
            <a:ext cx="125280" cy="9000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4513320" y="1644480"/>
            <a:ext cx="117360" cy="89064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4923000" y="1479600"/>
            <a:ext cx="126720" cy="10555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803760" y="1635120"/>
            <a:ext cx="118800" cy="90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3803760" y="1635120"/>
            <a:ext cx="118800" cy="9000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221000" y="1552680"/>
            <a:ext cx="119160" cy="982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4221000" y="1552680"/>
            <a:ext cx="119160" cy="9824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630680" y="1306440"/>
            <a:ext cx="119160" cy="1228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4630680" y="1306440"/>
            <a:ext cx="119160" cy="1228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5049720" y="1542960"/>
            <a:ext cx="117720" cy="992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5049720" y="1542960"/>
            <a:ext cx="117720" cy="99216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3741840" y="1173240"/>
            <a:ext cx="0" cy="225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719520" y="117324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4157640" y="1522080"/>
            <a:ext cx="0" cy="1126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138560" y="152244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 flipV="1">
            <a:off x="4568760" y="1563840"/>
            <a:ext cx="0" cy="806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548240" y="156384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 flipV="1">
            <a:off x="4986360" y="1306080"/>
            <a:ext cx="0" cy="173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4965840" y="130644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741840" y="1398600"/>
            <a:ext cx="0" cy="216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719520" y="1614600"/>
            <a:ext cx="507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157640" y="1635120"/>
            <a:ext cx="0" cy="122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4138560" y="175752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4568760" y="1644480"/>
            <a:ext cx="0" cy="82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548240" y="172728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4986360" y="1479600"/>
            <a:ext cx="0" cy="183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965840" y="166356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 flipV="1">
            <a:off x="3859200" y="1571760"/>
            <a:ext cx="0" cy="63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838680" y="157176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flipV="1">
            <a:off x="4276800" y="1450440"/>
            <a:ext cx="0" cy="1018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255920" y="145080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V="1">
            <a:off x="4687920" y="1266840"/>
            <a:ext cx="0" cy="39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4667400" y="12668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V="1">
            <a:off x="5103720" y="1479600"/>
            <a:ext cx="0" cy="63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5084640" y="1479600"/>
            <a:ext cx="4788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859200" y="1635120"/>
            <a:ext cx="0" cy="604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838680" y="1695600"/>
            <a:ext cx="475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4276800" y="1552680"/>
            <a:ext cx="0" cy="102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4255920" y="1655640"/>
            <a:ext cx="493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4687920" y="1306440"/>
            <a:ext cx="0" cy="41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667400" y="1347840"/>
            <a:ext cx="489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5103720" y="1542960"/>
            <a:ext cx="0" cy="716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5084640" y="1614600"/>
            <a:ext cx="4788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594240" y="938160"/>
            <a:ext cx="0" cy="1596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594240" y="253512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594240" y="221760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594240" y="190008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594240" y="157176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3594240" y="125568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594240" y="938160"/>
            <a:ext cx="3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594240" y="2535120"/>
            <a:ext cx="1663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3594240" y="248256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4013280" y="248256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4430880" y="248256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4840200" y="248256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V="1">
            <a:off x="5257800" y="248256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702600" y="620640"/>
            <a:ext cx="1608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PI weight/Body weigh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455280" y="24541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455280" y="2136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397320" y="1819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397320" y="14907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397320" y="11732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397320" y="857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746520" y="267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4164120" y="267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4575240" y="267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4992840" y="267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5238000" y="2670120"/>
            <a:ext cx="62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W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 rot="16200000">
            <a:off x="2793240" y="1840680"/>
            <a:ext cx="968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ight (mg/g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468360" y="-360"/>
            <a:ext cx="8229600" cy="43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1. Clinic paramet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692360" y="431964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900000" y="437832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1332000" y="410364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2100240" y="374508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4500720" y="1052640"/>
            <a:ext cx="38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6659640" y="112392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8005680" y="106668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7093080" y="1197000"/>
            <a:ext cx="38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7574040" y="120960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3708360" y="134136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067280" y="1197000"/>
            <a:ext cx="38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4910040" y="1268280"/>
            <a:ext cx="38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4175280" y="4292640"/>
            <a:ext cx="46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3708360" y="479736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4175280" y="5170320"/>
            <a:ext cx="46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708360" y="545940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2268360" y="184464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5327640" y="1316160"/>
            <a:ext cx="63360" cy="73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5328000" y="1460520"/>
            <a:ext cx="23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5291280" y="1787400"/>
            <a:ext cx="63360" cy="71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5219640" y="185904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8352000" y="1341360"/>
            <a:ext cx="63360" cy="73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8352360" y="1486080"/>
            <a:ext cx="23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8315280" y="1812960"/>
            <a:ext cx="6372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8244000" y="1884240"/>
            <a:ext cx="97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2556000" y="3429000"/>
            <a:ext cx="63360" cy="73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2556360" y="3573360"/>
            <a:ext cx="23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2519280" y="3900600"/>
            <a:ext cx="6372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2448000" y="397188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PC1L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1T15:33:07Z</dcterms:created>
  <dc:creator>hsl</dc:creator>
  <dc:description/>
  <dc:language>en-US</dc:language>
  <cp:lastModifiedBy>sanmu</cp:lastModifiedBy>
  <dcterms:modified xsi:type="dcterms:W3CDTF">2015-03-04T01:02:22Z</dcterms:modified>
  <cp:revision>361</cp:revision>
  <dc:subject/>
  <dc:title>Loss of NPC1L1 renders mice resistant to azoxymethane/dextran sulfate sodium-induced colon tumorigenesis</dc:title>
</cp:coreProperties>
</file>